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0E3"/>
    <a:srgbClr val="EAEAEA"/>
    <a:srgbClr val="FF3300"/>
    <a:srgbClr val="FDDAD3"/>
    <a:srgbClr val="F2F2F2"/>
    <a:srgbClr val="000000"/>
    <a:srgbClr val="FF0000"/>
    <a:srgbClr val="969696"/>
    <a:srgbClr val="FFFF99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971" autoAdjust="0"/>
    <p:restoredTop sz="98138" autoAdjust="0"/>
  </p:normalViewPr>
  <p:slideViewPr>
    <p:cSldViewPr snapToGrid="0">
      <p:cViewPr>
        <p:scale>
          <a:sx n="60" d="100"/>
          <a:sy n="60" d="100"/>
        </p:scale>
        <p:origin x="-2352" y="1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170238" cy="481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851" tIns="47425" rIns="94851" bIns="47425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200" b="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560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143375" y="0"/>
            <a:ext cx="3170238" cy="481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851" tIns="47425" rIns="94851" bIns="47425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latin typeface="Arial" charset="0"/>
              </a:defRPr>
            </a:lvl1pPr>
          </a:lstStyle>
          <a:p>
            <a:pPr>
              <a:defRPr/>
            </a:pPr>
            <a:fld id="{4ABDD6F3-8104-49FC-8760-29917DE3C853}" type="datetimeFigureOut">
              <a:rPr lang="en-US"/>
              <a:pPr>
                <a:defRPr/>
              </a:pPr>
              <a:t>4/22/2013</a:t>
            </a:fld>
            <a:endParaRPr lang="en-US"/>
          </a:p>
        </p:txBody>
      </p:sp>
      <p:sp>
        <p:nvSpPr>
          <p:cNvPr id="922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306638" y="719138"/>
            <a:ext cx="2701925" cy="36004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31838" y="4560888"/>
            <a:ext cx="5851525" cy="4321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851" tIns="47425" rIns="94851" bIns="4742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2560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118600"/>
            <a:ext cx="3170238" cy="481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851" tIns="47425" rIns="94851" bIns="47425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200" b="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2560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143375" y="9118600"/>
            <a:ext cx="3170238" cy="481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4851" tIns="47425" rIns="94851" bIns="47425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 b="0">
                <a:latin typeface="Arial" charset="0"/>
              </a:defRPr>
            </a:lvl1pPr>
          </a:lstStyle>
          <a:p>
            <a:pPr>
              <a:defRPr/>
            </a:pPr>
            <a:fld id="{DC6EF531-2FBF-4A31-A877-FA55B22E1F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40928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4F8F4C-B716-4992-882F-8515E47516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571000-81B9-4E48-8A06-45CC88226B6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D1665F-6C7A-45F4-92B1-C610EE7BD3F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, Conten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35052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35052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5B6F3DB-753A-4D56-AC5E-3700E282F5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26BF76F-77FC-4B70-B9DA-7B5C43C165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719BD7-47E7-4C07-82BA-57E7D88E77A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357018-96DB-4105-9ADD-D233646813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BF7A72-1115-431F-AB84-1AF466522A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DDE9C3-6C39-4E0C-AD06-34EB97C01B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628027-440B-46A6-9EC6-9356968183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534B3F-4E0A-4C42-A004-7513FF0067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B32B7D-984A-4FD7-AF0B-5FDBA2500A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736602-EB1A-4E91-83AF-0B7989B123F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Arial" charset="0"/>
              </a:defRPr>
            </a:lvl1pPr>
          </a:lstStyle>
          <a:p>
            <a:pPr>
              <a:defRPr/>
            </a:pPr>
            <a:fld id="{1B435E39-2E96-494E-A30D-59A48F00AE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90"/>
          <p:cNvSpPr txBox="1"/>
          <p:nvPr/>
        </p:nvSpPr>
        <p:spPr>
          <a:xfrm>
            <a:off x="726717" y="295583"/>
            <a:ext cx="21604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WT RT</a:t>
            </a:r>
            <a:endParaRPr lang="en-US" sz="600" dirty="0"/>
          </a:p>
        </p:txBody>
      </p:sp>
      <p:sp>
        <p:nvSpPr>
          <p:cNvPr id="261" name="Text Box 228"/>
          <p:cNvSpPr txBox="1">
            <a:spLocks noChangeArrowheads="1"/>
          </p:cNvSpPr>
          <p:nvPr/>
        </p:nvSpPr>
        <p:spPr bwMode="auto">
          <a:xfrm>
            <a:off x="224586" y="7006133"/>
            <a:ext cx="212244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100" dirty="0" smtClean="0">
                <a:cs typeface="Times New Roman" pitchFamily="18" charset="0"/>
              </a:rPr>
              <a:t>Additional </a:t>
            </a:r>
            <a:r>
              <a:rPr lang="en-US" sz="1100" dirty="0">
                <a:cs typeface="Times New Roman" pitchFamily="18" charset="0"/>
              </a:rPr>
              <a:t>F</a:t>
            </a:r>
            <a:r>
              <a:rPr lang="en-US" sz="1100" dirty="0" smtClean="0">
                <a:cs typeface="Times New Roman" pitchFamily="18" charset="0"/>
              </a:rPr>
              <a:t>igure </a:t>
            </a:r>
            <a:r>
              <a:rPr lang="en-US" sz="1100" dirty="0">
                <a:cs typeface="Times New Roman" pitchFamily="18" charset="0"/>
              </a:rPr>
              <a:t>1</a:t>
            </a:r>
            <a:endParaRPr lang="en-US" sz="1100" b="0" dirty="0">
              <a:cs typeface="Times New Roman" pitchFamily="18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1" y="59398"/>
            <a:ext cx="6858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Effect of K65R on formation of RT·T/P</a:t>
            </a:r>
            <a:r>
              <a:rPr lang="en-US" baseline="-25000" dirty="0" smtClean="0"/>
              <a:t>EFdA-MP</a:t>
            </a:r>
            <a:r>
              <a:rPr lang="en-US" dirty="0" smtClean="0"/>
              <a:t> binary complex</a:t>
            </a:r>
            <a:endParaRPr lang="en-US" baseline="-25000" dirty="0"/>
          </a:p>
        </p:txBody>
      </p:sp>
      <p:pic>
        <p:nvPicPr>
          <p:cNvPr id="18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40" t="4431" r="50000" b="79876"/>
          <a:stretch/>
        </p:blipFill>
        <p:spPr bwMode="auto">
          <a:xfrm>
            <a:off x="726717" y="851968"/>
            <a:ext cx="2169032" cy="640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68" t="7383" r="10815" b="76924"/>
          <a:stretch/>
        </p:blipFill>
        <p:spPr bwMode="auto">
          <a:xfrm>
            <a:off x="3539469" y="851968"/>
            <a:ext cx="2140815" cy="640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7317" y="1219094"/>
            <a:ext cx="843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0" dirty="0" smtClean="0"/>
              <a:t>Free T/P</a:t>
            </a:r>
            <a:r>
              <a:rPr lang="en-US" sz="700" b="0" baseline="-25000" dirty="0" smtClean="0"/>
              <a:t>EFdA-MP</a:t>
            </a:r>
            <a:endParaRPr lang="en-US" sz="700" b="0" baseline="-25000" dirty="0"/>
          </a:p>
        </p:txBody>
      </p:sp>
      <p:sp>
        <p:nvSpPr>
          <p:cNvPr id="6" name="TextBox 5"/>
          <p:cNvSpPr txBox="1"/>
          <p:nvPr/>
        </p:nvSpPr>
        <p:spPr>
          <a:xfrm>
            <a:off x="102408" y="793448"/>
            <a:ext cx="13972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0" dirty="0" smtClean="0"/>
              <a:t>RT·T/P</a:t>
            </a:r>
            <a:r>
              <a:rPr lang="en-US" sz="700" b="0" baseline="-25000" dirty="0" smtClean="0"/>
              <a:t>EFdA-MP</a:t>
            </a:r>
            <a:endParaRPr lang="en-US" sz="700" b="0" baseline="-25000" dirty="0"/>
          </a:p>
        </p:txBody>
      </p:sp>
      <p:grpSp>
        <p:nvGrpSpPr>
          <p:cNvPr id="10" name="Group 9"/>
          <p:cNvGrpSpPr/>
          <p:nvPr/>
        </p:nvGrpSpPr>
        <p:grpSpPr>
          <a:xfrm>
            <a:off x="635274" y="690989"/>
            <a:ext cx="2342747" cy="200055"/>
            <a:chOff x="635274" y="625154"/>
            <a:chExt cx="2342747" cy="200055"/>
          </a:xfrm>
        </p:grpSpPr>
        <p:sp>
          <p:nvSpPr>
            <p:cNvPr id="8" name="TextBox 7"/>
            <p:cNvSpPr txBox="1"/>
            <p:nvPr/>
          </p:nvSpPr>
          <p:spPr>
            <a:xfrm>
              <a:off x="635274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 smtClean="0"/>
                <a:t>0</a:t>
              </a:r>
              <a:endParaRPr lang="en-US" sz="700" b="0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85412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2</a:t>
              </a: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072978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3</a:t>
              </a: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291830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4</a:t>
              </a: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510682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5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1729534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6</a:t>
              </a: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94838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7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2167238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8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2386090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9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260494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 smtClean="0"/>
                <a:t>10</a:t>
              </a:r>
              <a:endParaRPr lang="en-US" sz="700" b="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726717" y="535733"/>
            <a:ext cx="21604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0" dirty="0" smtClean="0"/>
              <a:t>[RT]:[T/P</a:t>
            </a:r>
            <a:r>
              <a:rPr lang="en-US" sz="700" b="0" baseline="-25000" dirty="0" smtClean="0"/>
              <a:t>EFdA-MP</a:t>
            </a:r>
            <a:r>
              <a:rPr lang="en-US" sz="700" b="0" dirty="0" smtClean="0"/>
              <a:t>] ratios</a:t>
            </a:r>
            <a:endParaRPr lang="en-US" sz="700" b="0" dirty="0"/>
          </a:p>
        </p:txBody>
      </p:sp>
      <p:sp>
        <p:nvSpPr>
          <p:cNvPr id="192" name="TextBox 191"/>
          <p:cNvSpPr txBox="1"/>
          <p:nvPr/>
        </p:nvSpPr>
        <p:spPr>
          <a:xfrm>
            <a:off x="3519832" y="294368"/>
            <a:ext cx="21604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K65R RT</a:t>
            </a:r>
            <a:endParaRPr lang="en-US" sz="600" dirty="0"/>
          </a:p>
        </p:txBody>
      </p:sp>
      <p:sp>
        <p:nvSpPr>
          <p:cNvPr id="194" name="TextBox 193"/>
          <p:cNvSpPr txBox="1"/>
          <p:nvPr/>
        </p:nvSpPr>
        <p:spPr>
          <a:xfrm>
            <a:off x="2785798" y="1217879"/>
            <a:ext cx="843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0" dirty="0" smtClean="0"/>
              <a:t>Free T/P</a:t>
            </a:r>
            <a:r>
              <a:rPr lang="en-US" sz="700" b="0" baseline="-25000" dirty="0" smtClean="0"/>
              <a:t>EFdA-MP</a:t>
            </a:r>
            <a:endParaRPr lang="en-US" sz="700" b="0" baseline="-25000" dirty="0"/>
          </a:p>
        </p:txBody>
      </p:sp>
      <p:sp>
        <p:nvSpPr>
          <p:cNvPr id="195" name="TextBox 194"/>
          <p:cNvSpPr txBox="1"/>
          <p:nvPr/>
        </p:nvSpPr>
        <p:spPr>
          <a:xfrm>
            <a:off x="2895523" y="792233"/>
            <a:ext cx="13972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0" dirty="0" smtClean="0"/>
              <a:t>RT·T/P</a:t>
            </a:r>
            <a:r>
              <a:rPr lang="en-US" sz="700" b="0" baseline="-25000" dirty="0" smtClean="0"/>
              <a:t>EFdA-MP</a:t>
            </a:r>
            <a:endParaRPr lang="en-US" sz="700" b="0" baseline="-25000" dirty="0"/>
          </a:p>
        </p:txBody>
      </p:sp>
      <p:grpSp>
        <p:nvGrpSpPr>
          <p:cNvPr id="196" name="Group 195"/>
          <p:cNvGrpSpPr/>
          <p:nvPr/>
        </p:nvGrpSpPr>
        <p:grpSpPr>
          <a:xfrm>
            <a:off x="3428389" y="689774"/>
            <a:ext cx="2342747" cy="200055"/>
            <a:chOff x="635274" y="625154"/>
            <a:chExt cx="2342747" cy="200055"/>
          </a:xfrm>
        </p:grpSpPr>
        <p:sp>
          <p:nvSpPr>
            <p:cNvPr id="197" name="TextBox 196"/>
            <p:cNvSpPr txBox="1"/>
            <p:nvPr/>
          </p:nvSpPr>
          <p:spPr>
            <a:xfrm>
              <a:off x="635274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 smtClean="0"/>
                <a:t>0</a:t>
              </a:r>
              <a:endParaRPr lang="en-US" sz="700" b="0" dirty="0"/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85412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2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1072978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3</a:t>
              </a: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1291830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4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1510682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5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1729534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6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194838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7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2167238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8</a:t>
              </a: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2386090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/>
                <a:t>9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2604946" y="625154"/>
              <a:ext cx="3730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0" dirty="0" smtClean="0"/>
                <a:t>10</a:t>
              </a:r>
              <a:endParaRPr lang="en-US" sz="700" b="0" dirty="0"/>
            </a:p>
          </p:txBody>
        </p:sp>
      </p:grpSp>
      <p:sp>
        <p:nvSpPr>
          <p:cNvPr id="207" name="TextBox 206"/>
          <p:cNvSpPr txBox="1"/>
          <p:nvPr/>
        </p:nvSpPr>
        <p:spPr>
          <a:xfrm>
            <a:off x="3519832" y="534518"/>
            <a:ext cx="21604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0" dirty="0" smtClean="0"/>
              <a:t>[RT]:[T/P</a:t>
            </a:r>
            <a:r>
              <a:rPr lang="en-US" sz="700" b="0" baseline="-25000" dirty="0" smtClean="0"/>
              <a:t>EFdA-MP</a:t>
            </a:r>
            <a:r>
              <a:rPr lang="en-US" sz="700" b="0" dirty="0" smtClean="0"/>
              <a:t>] ratios</a:t>
            </a:r>
            <a:endParaRPr lang="en-US" sz="700" b="0" dirty="0"/>
          </a:p>
        </p:txBody>
      </p:sp>
    </p:spTree>
    <p:extLst>
      <p:ext uri="{BB962C8B-B14F-4D97-AF65-F5344CB8AC3E}">
        <p14:creationId xmlns:p14="http://schemas.microsoft.com/office/powerpoint/2010/main" val="2421724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04</TotalTime>
  <Words>54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University of Missouri Health Car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efteris</dc:creator>
  <cp:lastModifiedBy>Lefteris</cp:lastModifiedBy>
  <cp:revision>849</cp:revision>
  <dcterms:created xsi:type="dcterms:W3CDTF">2009-02-09T03:56:14Z</dcterms:created>
  <dcterms:modified xsi:type="dcterms:W3CDTF">2013-04-22T21:59:15Z</dcterms:modified>
</cp:coreProperties>
</file>